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7562850" cy="10688638"/>
  <p:notesSz cx="68580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367">
          <p15:clr>
            <a:srgbClr val="A4A3A4"/>
          </p15:clr>
        </p15:guide>
        <p15:guide id="2" pos="238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FF"/>
    <a:srgbClr val="009900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99" autoAdjust="0"/>
    <p:restoredTop sz="94678" autoAdjust="0"/>
  </p:normalViewPr>
  <p:slideViewPr>
    <p:cSldViewPr>
      <p:cViewPr varScale="1">
        <p:scale>
          <a:sx n="70" d="100"/>
          <a:sy n="70" d="100"/>
        </p:scale>
        <p:origin x="3150" y="78"/>
      </p:cViewPr>
      <p:guideLst>
        <p:guide orient="horz" pos="3367"/>
        <p:guide pos="23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FCFE574A-5C6D-4C3E-96B5-CC6F2BFC42DC}" type="datetimeFigureOut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4638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6425"/>
            <a:ext cx="5486400" cy="41830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BCDE5272-40E6-44C0-9409-99415B470BD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5" y="3320409"/>
            <a:ext cx="6428423" cy="229112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4429" y="6056896"/>
            <a:ext cx="5293995" cy="27315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3D2BA9-94EA-4E1B-B2E2-1FF66E87B5A3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374E8D-27A3-4516-8023-31E871BB7EC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5F8623-BDDF-469D-A4FD-772D49CE403E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75148A-D1CD-406B-92DA-CFDED20DDA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83067" y="428044"/>
            <a:ext cx="1701641" cy="911998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8143" y="428044"/>
            <a:ext cx="4978876" cy="911998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742EAE-18B1-42F2-88AC-53E2E91134B1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4239AC-4CF6-47E2-9538-3D943B1598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7107E5-814F-41E0-9509-1400C349D737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0A21A5-E6FB-433D-8213-A959553D75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414" y="6868441"/>
            <a:ext cx="6428423" cy="212288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414" y="4530302"/>
            <a:ext cx="6428423" cy="233813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FC1EB4-25EB-4DED-A799-B187006E7BFE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5FF4D3-3CC6-4ACE-9922-8EB91877E3A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8143" y="2494018"/>
            <a:ext cx="3340259" cy="7054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4450" y="2494018"/>
            <a:ext cx="3340259" cy="7054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6B8595-0DE3-47A4-AB83-D5C357C68ADF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D32C96-FDE6-48F5-B74D-C51DECEFA4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144" y="2392574"/>
            <a:ext cx="3341572" cy="9971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144" y="3389685"/>
            <a:ext cx="3341572" cy="615833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1824" y="2392574"/>
            <a:ext cx="3342885" cy="9971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1824" y="3389685"/>
            <a:ext cx="3342885" cy="615833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F67336-D99B-4F74-92CA-A64E60A33B1B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DDE954-8A04-440D-8DFA-4F6D0E49E18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7EF665-4D12-4674-9E22-7EB98DCF73DE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471FF-E78A-41DC-9927-0F7A43BF5E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2006E7-0676-423A-AFCA-F2C3FF86A6E1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3E7FAE-5D37-4225-BE0B-07722479D41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144" y="425566"/>
            <a:ext cx="2488126" cy="181113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6865" y="425568"/>
            <a:ext cx="4227843" cy="912245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8144" y="2236697"/>
            <a:ext cx="2488126" cy="73113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45FEA7-0920-480F-B5D6-9EA80B1FBE50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66AB4-A5E8-40ED-AA74-AFDE6896CA9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2372" y="7482047"/>
            <a:ext cx="4537710" cy="88329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2372" y="955050"/>
            <a:ext cx="4537710" cy="6413183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2372" y="8365344"/>
            <a:ext cx="4537710" cy="125443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DE743B-84EF-4678-96BA-9F6D9C1EE319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48E142-A490-4A1A-B797-6CFF32FF65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77825" y="428625"/>
            <a:ext cx="6807200" cy="1781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77825" y="2493963"/>
            <a:ext cx="6807200" cy="7054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7825" y="9906000"/>
            <a:ext cx="1765300" cy="5699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E97CF7C-B991-4167-961B-FB2DB4A0F80D}" type="datetime1">
              <a:rPr lang="en-US"/>
              <a:pPr>
                <a:defRPr/>
              </a:pPr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4450" y="9906000"/>
            <a:ext cx="2393950" cy="5699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19725" y="9906000"/>
            <a:ext cx="1765300" cy="5699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0D6F90D-2AA7-4792-A150-948C8E2DF4D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5D8F97A-D730-45FC-BDAD-02F6FFDA6BFD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  <p:sp>
        <p:nvSpPr>
          <p:cNvPr id="4100" name="Rectangle 10"/>
          <p:cNvSpPr>
            <a:spLocks noChangeArrowheads="1"/>
          </p:cNvSpPr>
          <p:nvPr/>
        </p:nvSpPr>
        <p:spPr bwMode="auto">
          <a:xfrm>
            <a:off x="2181225" y="2296319"/>
            <a:ext cx="5105400" cy="11695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Fig. S14: </a:t>
            </a:r>
            <a:r>
              <a:rPr lang="en-US" sz="1000" b="1" dirty="0" err="1"/>
              <a:t>InterPro</a:t>
            </a:r>
            <a:r>
              <a:rPr lang="en-US" sz="1000" b="1" dirty="0"/>
              <a:t> domain distribution (n=212) from the putative R gene in 9 Fabaceae species. </a:t>
            </a:r>
            <a:r>
              <a:rPr lang="en-US" sz="1000" dirty="0"/>
              <a:t>The set size represented by light blue bars indicates the total number of species a particular domain is present. Columns 1-9 represent 9 different species including, </a:t>
            </a:r>
            <a:r>
              <a:rPr lang="en-US" sz="1000" i="1" dirty="0"/>
              <a:t>Glycine</a:t>
            </a:r>
            <a:r>
              <a:rPr lang="en-US" sz="1000" dirty="0"/>
              <a:t> </a:t>
            </a:r>
            <a:r>
              <a:rPr lang="en-US" sz="1000" i="1" dirty="0"/>
              <a:t>max</a:t>
            </a:r>
            <a:r>
              <a:rPr lang="en-US" sz="1000" dirty="0"/>
              <a:t> (1), </a:t>
            </a:r>
            <a:r>
              <a:rPr lang="en-US" sz="1000" i="1" dirty="0"/>
              <a:t>Phaseolus vulgaris </a:t>
            </a:r>
            <a:r>
              <a:rPr lang="en-US" sz="1000" dirty="0"/>
              <a:t>(2), </a:t>
            </a:r>
            <a:r>
              <a:rPr lang="en-US" sz="1000" i="1" dirty="0" err="1"/>
              <a:t>Trifolium</a:t>
            </a:r>
            <a:r>
              <a:rPr lang="en-US" sz="1000" i="1" dirty="0"/>
              <a:t> pretense </a:t>
            </a:r>
            <a:r>
              <a:rPr lang="en-US" sz="1000" dirty="0"/>
              <a:t>(3), </a:t>
            </a:r>
            <a:r>
              <a:rPr lang="en-US" sz="1000" i="1" dirty="0"/>
              <a:t>Vigna angularis </a:t>
            </a:r>
            <a:r>
              <a:rPr lang="en-US" sz="1000" dirty="0"/>
              <a:t>(4), </a:t>
            </a:r>
            <a:r>
              <a:rPr lang="en-US" sz="1000" i="1" dirty="0"/>
              <a:t>Vigna</a:t>
            </a:r>
            <a:r>
              <a:rPr lang="en-US" sz="1000" dirty="0"/>
              <a:t> </a:t>
            </a:r>
            <a:r>
              <a:rPr lang="en-US" sz="1000" i="1" dirty="0"/>
              <a:t>radiata</a:t>
            </a:r>
            <a:r>
              <a:rPr lang="en-US" sz="1000" dirty="0"/>
              <a:t> (5), </a:t>
            </a:r>
            <a:r>
              <a:rPr lang="en-US" sz="1000" i="1" dirty="0" err="1"/>
              <a:t>Lupinus</a:t>
            </a:r>
            <a:r>
              <a:rPr lang="en-US" sz="1000" dirty="0"/>
              <a:t> </a:t>
            </a:r>
            <a:r>
              <a:rPr lang="en-US" sz="1000" i="1" dirty="0" err="1"/>
              <a:t>angustifolius</a:t>
            </a:r>
            <a:r>
              <a:rPr lang="en-US" sz="1000" i="1" dirty="0"/>
              <a:t> </a:t>
            </a:r>
            <a:r>
              <a:rPr lang="en-US" sz="1000" dirty="0"/>
              <a:t>(6), </a:t>
            </a:r>
            <a:r>
              <a:rPr lang="en-US" sz="1000" i="1" dirty="0"/>
              <a:t>Medicago </a:t>
            </a:r>
            <a:r>
              <a:rPr lang="en-US" sz="1000" i="1" dirty="0" err="1"/>
              <a:t>truncatula</a:t>
            </a:r>
            <a:r>
              <a:rPr lang="en-US" sz="1000" i="1" dirty="0"/>
              <a:t> </a:t>
            </a:r>
            <a:r>
              <a:rPr lang="en-US" sz="1000" dirty="0"/>
              <a:t>(7), </a:t>
            </a:r>
            <a:r>
              <a:rPr lang="en-US" sz="1000" i="1" dirty="0"/>
              <a:t>Pisum sativum </a:t>
            </a:r>
            <a:r>
              <a:rPr lang="en-US" sz="1000" dirty="0"/>
              <a:t>(8), and </a:t>
            </a:r>
            <a:r>
              <a:rPr lang="en-US" sz="1000" i="1" dirty="0"/>
              <a:t>Vigna unguiculate (</a:t>
            </a:r>
            <a:r>
              <a:rPr lang="en-US" sz="1000" dirty="0"/>
              <a:t>9</a:t>
            </a:r>
            <a:r>
              <a:rPr lang="en-US" sz="1000" i="1" dirty="0"/>
              <a:t>)</a:t>
            </a:r>
            <a:r>
              <a:rPr lang="en-US" sz="1000" dirty="0"/>
              <a:t>. The presence and absence of domains in each column are shown by dark and light circles, respectively.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594E6DE5-82A1-4274-9171-06510C5F0DA5}"/>
              </a:ext>
            </a:extLst>
          </p:cNvPr>
          <p:cNvGrpSpPr/>
          <p:nvPr/>
        </p:nvGrpSpPr>
        <p:grpSpPr>
          <a:xfrm>
            <a:off x="47625" y="38889"/>
            <a:ext cx="2009549" cy="10641018"/>
            <a:chOff x="2133546" y="38889"/>
            <a:chExt cx="2009549" cy="10641018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ED807AC8-75D4-409A-B27F-77AACB0CF2CD}"/>
                </a:ext>
              </a:extLst>
            </p:cNvPr>
            <p:cNvGrpSpPr/>
            <p:nvPr/>
          </p:nvGrpSpPr>
          <p:grpSpPr>
            <a:xfrm>
              <a:off x="2543173" y="38889"/>
              <a:ext cx="1533527" cy="190225"/>
              <a:chOff x="485739" y="34126"/>
              <a:chExt cx="1533527" cy="190225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A496D5D7-8A75-4AD6-A041-042424C9233D}"/>
                  </a:ext>
                </a:extLst>
              </p:cNvPr>
              <p:cNvGrpSpPr/>
              <p:nvPr/>
            </p:nvGrpSpPr>
            <p:grpSpPr>
              <a:xfrm>
                <a:off x="976313" y="34126"/>
                <a:ext cx="1042953" cy="187014"/>
                <a:chOff x="976313" y="48415"/>
                <a:chExt cx="1042953" cy="187014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59AD85FA-6F2D-44B1-9AFC-05F513090B18}"/>
                    </a:ext>
                  </a:extLst>
                </p:cNvPr>
                <p:cNvGrpSpPr/>
                <p:nvPr/>
              </p:nvGrpSpPr>
              <p:grpSpPr>
                <a:xfrm>
                  <a:off x="976313" y="50282"/>
                  <a:ext cx="738169" cy="185147"/>
                  <a:chOff x="1109662" y="10397326"/>
                  <a:chExt cx="738169" cy="185147"/>
                </a:xfrm>
              </p:grpSpPr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E4BF8D23-DBF9-40C8-B220-0968A2AA75A0}"/>
                      </a:ext>
                    </a:extLst>
                  </p:cNvPr>
                  <p:cNvSpPr txBox="1"/>
                  <p:nvPr/>
                </p:nvSpPr>
                <p:spPr>
                  <a:xfrm>
                    <a:off x="1109662" y="10397807"/>
                    <a:ext cx="209556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b="1" dirty="0"/>
                      <a:t>1</a:t>
                    </a: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72499550-FA93-4506-8825-25627DB892C5}"/>
                      </a:ext>
                    </a:extLst>
                  </p:cNvPr>
                  <p:cNvSpPr txBox="1"/>
                  <p:nvPr/>
                </p:nvSpPr>
                <p:spPr>
                  <a:xfrm>
                    <a:off x="1214432" y="10397805"/>
                    <a:ext cx="209556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b="1" dirty="0"/>
                      <a:t>2</a:t>
                    </a:r>
                  </a:p>
                </p:txBody>
              </p: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7E364008-DF8E-499F-B559-B31CC2C9AE37}"/>
                      </a:ext>
                    </a:extLst>
                  </p:cNvPr>
                  <p:cNvSpPr txBox="1"/>
                  <p:nvPr/>
                </p:nvSpPr>
                <p:spPr>
                  <a:xfrm>
                    <a:off x="1319202" y="10397334"/>
                    <a:ext cx="209556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b="1" dirty="0"/>
                      <a:t>3</a:t>
                    </a: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9FFD0220-863F-4AB9-87CF-888D23C6CC7C}"/>
                      </a:ext>
                    </a:extLst>
                  </p:cNvPr>
                  <p:cNvSpPr txBox="1"/>
                  <p:nvPr/>
                </p:nvSpPr>
                <p:spPr>
                  <a:xfrm>
                    <a:off x="1428735" y="10397326"/>
                    <a:ext cx="209556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b="1" dirty="0"/>
                      <a:t>4</a:t>
                    </a:r>
                  </a:p>
                </p:txBody>
              </p:sp>
              <p:sp>
                <p:nvSpPr>
                  <p:cNvPr id="20" name="TextBox 19">
                    <a:extLst>
                      <a:ext uri="{FF2B5EF4-FFF2-40B4-BE49-F238E27FC236}">
                        <a16:creationId xmlns:a16="http://schemas.microsoft.com/office/drawing/2014/main" id="{3347A745-6353-4B47-B5D4-F42D70CEB0C7}"/>
                      </a:ext>
                    </a:extLst>
                  </p:cNvPr>
                  <p:cNvSpPr txBox="1"/>
                  <p:nvPr/>
                </p:nvSpPr>
                <p:spPr>
                  <a:xfrm>
                    <a:off x="1533505" y="10397334"/>
                    <a:ext cx="209556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b="1" dirty="0"/>
                      <a:t>5</a:t>
                    </a:r>
                  </a:p>
                </p:txBody>
              </p: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3507C15F-61A0-44EA-81CB-F45D20AE0C3B}"/>
                      </a:ext>
                    </a:extLst>
                  </p:cNvPr>
                  <p:cNvSpPr txBox="1"/>
                  <p:nvPr/>
                </p:nvSpPr>
                <p:spPr>
                  <a:xfrm>
                    <a:off x="1638275" y="10397326"/>
                    <a:ext cx="209556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b="1" dirty="0"/>
                      <a:t>6</a:t>
                    </a:r>
                  </a:p>
                </p:txBody>
              </p:sp>
            </p:grp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0DEE12F0-CD60-4D15-9543-8E99FD99CB65}"/>
                    </a:ext>
                  </a:extLst>
                </p:cNvPr>
                <p:cNvSpPr txBox="1"/>
                <p:nvPr/>
              </p:nvSpPr>
              <p:spPr>
                <a:xfrm>
                  <a:off x="1600170" y="48423"/>
                  <a:ext cx="20955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/>
                    <a:t>7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8AA5043D-7E84-46CC-8ECF-E3A99612AE8E}"/>
                    </a:ext>
                  </a:extLst>
                </p:cNvPr>
                <p:cNvSpPr txBox="1"/>
                <p:nvPr/>
              </p:nvSpPr>
              <p:spPr>
                <a:xfrm>
                  <a:off x="1704940" y="48415"/>
                  <a:ext cx="20955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/>
                    <a:t>8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D698C266-70D3-4FE5-8064-FCA6348C85B4}"/>
                    </a:ext>
                  </a:extLst>
                </p:cNvPr>
                <p:cNvSpPr txBox="1"/>
                <p:nvPr/>
              </p:nvSpPr>
              <p:spPr>
                <a:xfrm>
                  <a:off x="1809710" y="48415"/>
                  <a:ext cx="20955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/>
                    <a:t>9</a:t>
                  </a:r>
                </a:p>
              </p:txBody>
            </p:sp>
          </p:grp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C68E9AE2-95A1-4439-A327-D018BF11169C}"/>
                  </a:ext>
                </a:extLst>
              </p:cNvPr>
              <p:cNvSpPr txBox="1"/>
              <p:nvPr/>
            </p:nvSpPr>
            <p:spPr>
              <a:xfrm>
                <a:off x="485739" y="39685"/>
                <a:ext cx="5266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Domains</a:t>
                </a:r>
              </a:p>
            </p:txBody>
          </p:sp>
        </p:grp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B5AB4A5B-06A0-4B02-B4B8-DD84440CD9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09"/>
            <a:stretch/>
          </p:blipFill>
          <p:spPr>
            <a:xfrm>
              <a:off x="2133546" y="164307"/>
              <a:ext cx="2009549" cy="10515600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91</TotalTime>
  <Words>126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ulal</dc:creator>
  <cp:lastModifiedBy>Vishal Singh Negi</cp:lastModifiedBy>
  <cp:revision>218</cp:revision>
  <dcterms:created xsi:type="dcterms:W3CDTF">2011-10-28T20:08:33Z</dcterms:created>
  <dcterms:modified xsi:type="dcterms:W3CDTF">2022-11-11T16:09:02Z</dcterms:modified>
</cp:coreProperties>
</file>